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9472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8AA382-5D4E-4B0D-9460-01C341CFE35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56CF9C-3591-43DB-9739-742D0B6AD3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1A2100-C241-471C-BE4D-36C0416C7B5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5281AA-CBBB-4476-9E2B-5ADBE3D2C40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4AF389-015C-44D8-8A32-0AC58901FD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4E0BEF-37FB-402F-9A58-D3C733710E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2DD4DF-B2F3-477C-B294-F8C62D9391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2CEA72-B7CC-4E9E-9A9B-F55AB0ECFC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55703F-98D0-4A04-B183-B651D29C1B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B79834-92FF-4699-A3CC-A016CE2353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F903E8-5FFC-40C7-AFE0-65E796E8F5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1930D5-6043-4E17-9AAB-C4C0C35906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3CD761-C463-429F-B690-3635DD5755E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28760" y="714240"/>
          <a:ext cx="3214440" cy="2143440"/>
        </p:xfrm>
        <a:graphic>
          <a:graphicData uri="http://schemas.openxmlformats.org/drawingml/2006/table">
            <a:tbl>
              <a:tblPr/>
              <a:tblGrid>
                <a:gridCol w="2049480"/>
                <a:gridCol w="1164960"/>
              </a:tblGrid>
              <a:tr h="401760">
                <a:tc gridSpan="2"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ble S5. Classification of identified proteins based on their functional annotations in NCBInr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17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tegor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umbe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744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zym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744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otilit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780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bstrate of Icm/Do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888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ranscription regulate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744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aperon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744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xin production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780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know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04T12:57:45Z</dcterms:created>
  <dc:creator> 平田源内</dc:creator>
  <dc:description/>
  <dc:language>en-US</dc:language>
  <cp:lastModifiedBy>MiyakeMasaki</cp:lastModifiedBy>
  <dcterms:modified xsi:type="dcterms:W3CDTF">2010-03-02T01:34:43Z</dcterms:modified>
  <cp:revision>103</cp:revision>
  <dc:subject/>
  <dc:title>スライド 1</dc:title>
</cp:coreProperties>
</file>